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97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8CF05-75CE-D81B-3958-011A73ED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0A9B5-4BAF-AA20-AD4F-544556872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A4643-CEAB-ED4A-81F1-B042D4092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0ED0D-4A3D-4FAA-F91B-CD55D9E1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2B51B-2E43-599A-6838-96430361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5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73E9B-D4E7-E346-FB50-A41E0B8EF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8F6E18-6FA5-C8C9-870D-6A40E72E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A1AC-85A5-56DF-9A62-FAA70B931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957D5-0C61-5DC0-82FB-9F74D60D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46975-8E45-40EA-B91B-BBA29D679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D2956C-9585-C3A7-A934-74CA05A15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E2285-6BCE-8D45-2114-06BAE74C2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A9F5-51A9-258E-4259-FFF32975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9E6E3-3081-0DF3-9135-FED78B97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8B459-4246-5546-2666-46848F6AA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8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12D5-92DA-D71D-E7FF-1185C57EF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3AC3-5838-5686-979F-C4708EAB9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BCBBE-C65A-1D9B-06AB-5A829171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BD418-50AA-195E-9EF7-D37BD964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3E518-5ACE-5576-44E5-BE929C49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AAB84-091F-22D5-3A6C-2DC3AAC4C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6B9BA-F627-D1E2-DB31-4985C5D27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E6CB2-E836-6A59-C64E-F2318B43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1097C-65E4-6523-D969-7CCE35A7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D516-7B6B-8815-EB85-192C470E3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0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145D4-4F3E-DEF0-E52D-6F199945E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7D364-D78F-5285-CFE5-28351C6CC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EEA0D-DFDD-70C7-2A63-AED7EAD1A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DA67F-4A1E-0861-4C09-6E66646B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E79AA-DD26-89CD-01CC-9892E8406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6D811C-07A8-0FBC-47D4-89DD4BA7B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9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4007-89BB-BD77-871F-B1AA48E1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168E8-01A6-B85D-F9AE-23C401953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D23E6-9139-D575-2CCF-25C664743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9A8250-CF1B-3354-0556-08C73340F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5D328-D506-2928-BAF0-05A9108B5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F467DC-86FD-CA63-923D-03A7C1B09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4FF3B5-B688-9692-22E2-A444F44C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7691A-9CD4-1274-14E1-AC55E5585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07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6D0E-AD11-EA47-B1DC-01D7E0AA5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D4909-405A-165D-103C-1D7E95FD7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D9572-0B1D-FE6F-EF95-F5E64844D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EEC9F-7990-93B9-A120-28D153D8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03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903C99-819D-1F44-9492-14328391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3F52CA-9FF0-30C6-E2D9-60B1E91C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E4D404-9C29-4F76-6AAF-687EEF66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4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56EAF-B526-28C9-72E1-15BAA3BE8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04110-9824-D35B-CF74-FFAA3E956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DC3187-603B-0CAB-38C7-E86921C0E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FA8D5-E6AF-0212-F67F-ACFA6DFF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AD6B2-B43E-F50B-56D6-3F5269625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16575-FF07-F808-8E6F-44012E5A0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55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2E2D0-C57B-03DC-8B59-6147D3F05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6B405-2A04-9B3F-CAFC-16C4178268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BA778B-0D30-1763-F06E-00B2F19EF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BFAF-71E0-16DE-2FD1-F17396541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6507B-296A-BE8A-004A-9B9C54CF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94F8C-3B05-AC5F-D984-D5693E3A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4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508D78-3907-9E1F-6C27-99B43B6D1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EB8E4-6EFD-207A-B4BB-B6258EB5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A7D4-7F64-B9D1-8B5C-9FF21ADE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C2518-AE36-48D1-96F6-74333C097C54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2A2B5-108F-6F70-32EE-A377B5418F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33AA-3D25-AA0B-0995-A503FFCDF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5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2DBD81F-F66D-0955-1CA7-A2B0799E2B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304" y="2257403"/>
            <a:ext cx="6666735" cy="329516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1D06781-E6C9-579A-8F70-5335D3E22DC5}"/>
              </a:ext>
            </a:extLst>
          </p:cNvPr>
          <p:cNvSpPr txBox="1"/>
          <p:nvPr/>
        </p:nvSpPr>
        <p:spPr>
          <a:xfrm>
            <a:off x="5458451" y="1479737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L12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E369819-FB72-DA90-09AD-8705A3E4C7E5}"/>
              </a:ext>
            </a:extLst>
          </p:cNvPr>
          <p:cNvSpPr txBox="1"/>
          <p:nvPr/>
        </p:nvSpPr>
        <p:spPr>
          <a:xfrm>
            <a:off x="3279149" y="145115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2AF0B9C-34C1-E85F-7B2A-1263F767BCDD}"/>
              </a:ext>
            </a:extLst>
          </p:cNvPr>
          <p:cNvSpPr txBox="1"/>
          <p:nvPr/>
        </p:nvSpPr>
        <p:spPr>
          <a:xfrm>
            <a:off x="960032" y="148783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617899" y="185428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1622765" y="185428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E390-5396-151B-3669-F68D32BDDCB7}"/>
              </a:ext>
            </a:extLst>
          </p:cNvPr>
          <p:cNvSpPr txBox="1"/>
          <p:nvPr/>
        </p:nvSpPr>
        <p:spPr>
          <a:xfrm>
            <a:off x="2876861" y="188286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3907375" y="185428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254318-9923-99B2-2653-E7AE07F94C65}"/>
              </a:ext>
            </a:extLst>
          </p:cNvPr>
          <p:cNvSpPr txBox="1"/>
          <p:nvPr/>
        </p:nvSpPr>
        <p:spPr>
          <a:xfrm>
            <a:off x="5124025" y="185428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02179C-FD9A-ECD0-9E69-2422E8DE6D0F}"/>
              </a:ext>
            </a:extLst>
          </p:cNvPr>
          <p:cNvSpPr txBox="1"/>
          <p:nvPr/>
        </p:nvSpPr>
        <p:spPr>
          <a:xfrm>
            <a:off x="6191985" y="188286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AD12640-256C-0494-C56D-2F721C60FBDD}"/>
              </a:ext>
            </a:extLst>
          </p:cNvPr>
          <p:cNvSpPr txBox="1"/>
          <p:nvPr/>
        </p:nvSpPr>
        <p:spPr>
          <a:xfrm>
            <a:off x="7753175" y="1488436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077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15BF65B-AFCF-C654-15CD-3B98A63020C6}"/>
              </a:ext>
            </a:extLst>
          </p:cNvPr>
          <p:cNvSpPr txBox="1"/>
          <p:nvPr/>
        </p:nvSpPr>
        <p:spPr>
          <a:xfrm>
            <a:off x="7418749" y="1862979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8162C00-C226-1DCE-C9E6-AFFAADA6B818}"/>
              </a:ext>
            </a:extLst>
          </p:cNvPr>
          <p:cNvSpPr txBox="1"/>
          <p:nvPr/>
        </p:nvSpPr>
        <p:spPr>
          <a:xfrm>
            <a:off x="8486709" y="189155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FCF4D40-EDAD-CE05-A6D2-757903B4C49C}"/>
              </a:ext>
            </a:extLst>
          </p:cNvPr>
          <p:cNvSpPr txBox="1"/>
          <p:nvPr/>
        </p:nvSpPr>
        <p:spPr>
          <a:xfrm>
            <a:off x="10144005" y="1479737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DA23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DE1526A-A673-C6C5-6E01-E76E3BF47C7C}"/>
              </a:ext>
            </a:extLst>
          </p:cNvPr>
          <p:cNvSpPr txBox="1"/>
          <p:nvPr/>
        </p:nvSpPr>
        <p:spPr>
          <a:xfrm>
            <a:off x="9809579" y="185428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B959A25-B3AF-1929-962E-AC66FF28B683}"/>
              </a:ext>
            </a:extLst>
          </p:cNvPr>
          <p:cNvSpPr txBox="1"/>
          <p:nvPr/>
        </p:nvSpPr>
        <p:spPr>
          <a:xfrm>
            <a:off x="10877539" y="188286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1D30A700-100F-9807-9D30-CF274BA309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7214625" y="2260891"/>
            <a:ext cx="2132575" cy="2132575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F41D4939-F7B3-E6D5-BD65-98979E17A8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9580317" y="2223612"/>
            <a:ext cx="2132576" cy="21259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0925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1D06781-E6C9-579A-8F70-5335D3E22DC5}"/>
              </a:ext>
            </a:extLst>
          </p:cNvPr>
          <p:cNvSpPr txBox="1"/>
          <p:nvPr/>
        </p:nvSpPr>
        <p:spPr>
          <a:xfrm>
            <a:off x="5835994" y="161876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E369819-FB72-DA90-09AD-8705A3E4C7E5}"/>
              </a:ext>
            </a:extLst>
          </p:cNvPr>
          <p:cNvSpPr txBox="1"/>
          <p:nvPr/>
        </p:nvSpPr>
        <p:spPr>
          <a:xfrm>
            <a:off x="3514842" y="1651747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L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2AF0B9C-34C1-E85F-7B2A-1263F767BCDD}"/>
              </a:ext>
            </a:extLst>
          </p:cNvPr>
          <p:cNvSpPr txBox="1"/>
          <p:nvPr/>
        </p:nvSpPr>
        <p:spPr>
          <a:xfrm>
            <a:off x="1138845" y="166953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719499" y="2104759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1852511" y="210297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E390-5396-151B-3669-F68D32BDDCB7}"/>
              </a:ext>
            </a:extLst>
          </p:cNvPr>
          <p:cNvSpPr txBox="1"/>
          <p:nvPr/>
        </p:nvSpPr>
        <p:spPr>
          <a:xfrm>
            <a:off x="3161341" y="203886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4320001" y="204381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254318-9923-99B2-2653-E7AE07F94C65}"/>
              </a:ext>
            </a:extLst>
          </p:cNvPr>
          <p:cNvSpPr txBox="1"/>
          <p:nvPr/>
        </p:nvSpPr>
        <p:spPr>
          <a:xfrm>
            <a:off x="5522991" y="204683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02179C-FD9A-ECD0-9E69-2422E8DE6D0F}"/>
              </a:ext>
            </a:extLst>
          </p:cNvPr>
          <p:cNvSpPr txBox="1"/>
          <p:nvPr/>
        </p:nvSpPr>
        <p:spPr>
          <a:xfrm>
            <a:off x="6700333" y="2046835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FCC5C68-F646-F84E-8E8F-6D338EC10F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376956" y="696181"/>
            <a:ext cx="3294000" cy="691740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FB8183A-73E2-46E1-344A-52CF2827B8BE}"/>
              </a:ext>
            </a:extLst>
          </p:cNvPr>
          <p:cNvSpPr txBox="1"/>
          <p:nvPr/>
        </p:nvSpPr>
        <p:spPr>
          <a:xfrm>
            <a:off x="8061164" y="1678234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077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E6C21E4-FFA1-AE28-E115-49E22102DF21}"/>
              </a:ext>
            </a:extLst>
          </p:cNvPr>
          <p:cNvSpPr txBox="1"/>
          <p:nvPr/>
        </p:nvSpPr>
        <p:spPr>
          <a:xfrm>
            <a:off x="7726738" y="205277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6AC42E3-0479-27EC-5AE0-F9F51C66E920}"/>
              </a:ext>
            </a:extLst>
          </p:cNvPr>
          <p:cNvSpPr txBox="1"/>
          <p:nvPr/>
        </p:nvSpPr>
        <p:spPr>
          <a:xfrm>
            <a:off x="8794698" y="208135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9F021F-AA6B-9B16-5971-2D5C22589C6E}"/>
              </a:ext>
            </a:extLst>
          </p:cNvPr>
          <p:cNvSpPr txBox="1"/>
          <p:nvPr/>
        </p:nvSpPr>
        <p:spPr>
          <a:xfrm>
            <a:off x="10451994" y="1669535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DA23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F437764-A6E4-D40D-A6B0-4BCF7134886D}"/>
              </a:ext>
            </a:extLst>
          </p:cNvPr>
          <p:cNvSpPr txBox="1"/>
          <p:nvPr/>
        </p:nvSpPr>
        <p:spPr>
          <a:xfrm>
            <a:off x="10117568" y="2044078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784C712-EC61-9675-960A-711679A36DB5}"/>
              </a:ext>
            </a:extLst>
          </p:cNvPr>
          <p:cNvSpPr txBox="1"/>
          <p:nvPr/>
        </p:nvSpPr>
        <p:spPr>
          <a:xfrm>
            <a:off x="11185528" y="207265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514DDCF0-698E-543F-D8C0-1609F15ACF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7596776" y="2472305"/>
            <a:ext cx="2016000" cy="2016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D3EAFEF-4A90-10AD-4E2D-AB152E3A793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51968"/>
          <a:stretch/>
        </p:blipFill>
        <p:spPr>
          <a:xfrm flipH="1">
            <a:off x="9916160" y="2472305"/>
            <a:ext cx="2091018" cy="20631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90171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1D06781-E6C9-579A-8F70-5335D3E22DC5}"/>
              </a:ext>
            </a:extLst>
          </p:cNvPr>
          <p:cNvSpPr txBox="1"/>
          <p:nvPr/>
        </p:nvSpPr>
        <p:spPr>
          <a:xfrm>
            <a:off x="5835994" y="161876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E369819-FB72-DA90-09AD-8705A3E4C7E5}"/>
              </a:ext>
            </a:extLst>
          </p:cNvPr>
          <p:cNvSpPr txBox="1"/>
          <p:nvPr/>
        </p:nvSpPr>
        <p:spPr>
          <a:xfrm>
            <a:off x="3514842" y="1651747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L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2AF0B9C-34C1-E85F-7B2A-1263F767BCDD}"/>
              </a:ext>
            </a:extLst>
          </p:cNvPr>
          <p:cNvSpPr txBox="1"/>
          <p:nvPr/>
        </p:nvSpPr>
        <p:spPr>
          <a:xfrm>
            <a:off x="1138845" y="166953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719499" y="2104759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1852511" y="210297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E390-5396-151B-3669-F68D32BDDCB7}"/>
              </a:ext>
            </a:extLst>
          </p:cNvPr>
          <p:cNvSpPr txBox="1"/>
          <p:nvPr/>
        </p:nvSpPr>
        <p:spPr>
          <a:xfrm>
            <a:off x="3161341" y="203886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4320001" y="204381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254318-9923-99B2-2653-E7AE07F94C65}"/>
              </a:ext>
            </a:extLst>
          </p:cNvPr>
          <p:cNvSpPr txBox="1"/>
          <p:nvPr/>
        </p:nvSpPr>
        <p:spPr>
          <a:xfrm>
            <a:off x="5522991" y="204683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02179C-FD9A-ECD0-9E69-2422E8DE6D0F}"/>
              </a:ext>
            </a:extLst>
          </p:cNvPr>
          <p:cNvSpPr txBox="1"/>
          <p:nvPr/>
        </p:nvSpPr>
        <p:spPr>
          <a:xfrm>
            <a:off x="6700333" y="2046835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9F021F-AA6B-9B16-5971-2D5C22589C6E}"/>
              </a:ext>
            </a:extLst>
          </p:cNvPr>
          <p:cNvSpPr txBox="1"/>
          <p:nvPr/>
        </p:nvSpPr>
        <p:spPr>
          <a:xfrm>
            <a:off x="8219067" y="1665202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DA23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F437764-A6E4-D40D-A6B0-4BCF7134886D}"/>
              </a:ext>
            </a:extLst>
          </p:cNvPr>
          <p:cNvSpPr txBox="1"/>
          <p:nvPr/>
        </p:nvSpPr>
        <p:spPr>
          <a:xfrm>
            <a:off x="7884641" y="203974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784C712-EC61-9675-960A-711679A36DB5}"/>
              </a:ext>
            </a:extLst>
          </p:cNvPr>
          <p:cNvSpPr txBox="1"/>
          <p:nvPr/>
        </p:nvSpPr>
        <p:spPr>
          <a:xfrm>
            <a:off x="8952601" y="2068325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41649A0-2BAB-2F14-D0D9-0B499D09E8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4780330" y="3148250"/>
            <a:ext cx="3294000" cy="20703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22AEA80-92A0-150A-DBA8-72F1C441B3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1223310" y="1897329"/>
            <a:ext cx="3294000" cy="4572167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E9CDA58-AD6F-162F-89F6-120D7D8C443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1968"/>
          <a:stretch/>
        </p:blipFill>
        <p:spPr>
          <a:xfrm flipH="1">
            <a:off x="7698266" y="2536412"/>
            <a:ext cx="2070326" cy="20427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5842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51</Words>
  <Application>Microsoft Office PowerPoint</Application>
  <PresentationFormat>Widescreen</PresentationFormat>
  <Paragraphs>4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6</cp:revision>
  <dcterms:created xsi:type="dcterms:W3CDTF">2024-06-06T16:34:22Z</dcterms:created>
  <dcterms:modified xsi:type="dcterms:W3CDTF">2024-06-06T17:47:07Z</dcterms:modified>
</cp:coreProperties>
</file>